
<file path=[Content_Types].xml><?xml version="1.0" encoding="utf-8"?>
<Types xmlns="http://schemas.openxmlformats.org/package/2006/content-types">
  <Default Extension="tmp" ContentType="image/png"/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7"/>
  </p:notesMasterIdLst>
  <p:sldIdLst>
    <p:sldId id="256" r:id="rId2"/>
    <p:sldId id="257" r:id="rId3"/>
    <p:sldId id="259" r:id="rId4"/>
    <p:sldId id="261" r:id="rId5"/>
    <p:sldId id="265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6163" autoAdjust="0"/>
  </p:normalViewPr>
  <p:slideViewPr>
    <p:cSldViewPr snapToGrid="0">
      <p:cViewPr>
        <p:scale>
          <a:sx n="238" d="100"/>
          <a:sy n="238" d="100"/>
        </p:scale>
        <p:origin x="258" y="-24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16484F-4E76-427D-A7B5-6B0BB1B9A7C2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69989C-B77B-4D78-8BE8-10FC7AE89D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905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on-intron structures of strawberry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L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s predicted from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.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sc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A)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. ×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nass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B) genomes. Genetic structures of 20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vML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68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×aMLO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s were constructed using Gene Structure Display Server 2.0 (GSDS)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69989C-B77B-4D78-8BE8-10FC7AE89DB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2418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irwise comparison of putativ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L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ding DNA sequences (CDS)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.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sc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. ×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nass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Percent sequence similarities among predicted 20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vMLO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68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×aMLO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s were calculated using multiple sequence alignment and tree building programs via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iou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oftware. Gene sequences similarities were visualized with heatmap using R-package “lattice”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69989C-B77B-4D78-8BE8-10FC7AE89DB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7015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614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865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122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411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93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408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210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057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129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456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908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06EE8-76E9-4BB7-801D-8345CF988FF6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8EF96-0BCD-436B-BA61-6A2B537C9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725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m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gi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mp"/><Relationship Id="rId2" Type="http://schemas.openxmlformats.org/officeDocument/2006/relationships/image" Target="../media/image6.tmp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95A049F-25B7-4457-B8E6-EB11882CD594}"/>
              </a:ext>
            </a:extLst>
          </p:cNvPr>
          <p:cNvSpPr txBox="1"/>
          <p:nvPr/>
        </p:nvSpPr>
        <p:spPr>
          <a:xfrm>
            <a:off x="0" y="0"/>
            <a:ext cx="10133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a</a:t>
            </a:r>
          </a:p>
        </p:txBody>
      </p:sp>
      <p:pic>
        <p:nvPicPr>
          <p:cNvPr id="3" name="Picture 2" descr="Screen Clipping">
            <a:extLst>
              <a:ext uri="{FF2B5EF4-FFF2-40B4-BE49-F238E27FC236}">
                <a16:creationId xmlns:a16="http://schemas.microsoft.com/office/drawing/2014/main" id="{0FBA0416-6126-42FB-BC1D-539E4631CD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07777"/>
            <a:ext cx="6858000" cy="3200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650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CED600D-50A7-4027-876C-84D395B404DD}"/>
              </a:ext>
            </a:extLst>
          </p:cNvPr>
          <p:cNvSpPr txBox="1"/>
          <p:nvPr/>
        </p:nvSpPr>
        <p:spPr>
          <a:xfrm>
            <a:off x="0" y="0"/>
            <a:ext cx="10229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5E0E65-35F8-4FFA-977A-1DEF537158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936" y="422910"/>
            <a:ext cx="5952536" cy="85610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7329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1712A93-1847-4A2B-8CD4-91ED2D74483F}"/>
              </a:ext>
            </a:extLst>
          </p:cNvPr>
          <p:cNvSpPr txBox="1"/>
          <p:nvPr/>
        </p:nvSpPr>
        <p:spPr>
          <a:xfrm>
            <a:off x="-41346" y="0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55794A3-C421-465B-9ACC-64E6BD0D9540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62802" y="348580"/>
            <a:ext cx="6732396" cy="6022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46488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BAA9216-9FAC-42A6-A40A-DA19A97C351C}"/>
              </a:ext>
            </a:extLst>
          </p:cNvPr>
          <p:cNvGrpSpPr/>
          <p:nvPr/>
        </p:nvGrpSpPr>
        <p:grpSpPr>
          <a:xfrm>
            <a:off x="760688" y="19456"/>
            <a:ext cx="5879132" cy="9144000"/>
            <a:chOff x="760688" y="0"/>
            <a:chExt cx="5879132" cy="9144000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5CD4C4FC-ECC1-4007-979F-F8A76EE4700C}"/>
                </a:ext>
              </a:extLst>
            </p:cNvPr>
            <p:cNvGrpSpPr/>
            <p:nvPr/>
          </p:nvGrpSpPr>
          <p:grpSpPr>
            <a:xfrm>
              <a:off x="765411" y="0"/>
              <a:ext cx="5874409" cy="9144000"/>
              <a:chOff x="765411" y="0"/>
              <a:chExt cx="5874409" cy="9144000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E3AEFA91-8A6F-401E-8CBE-18C3EBA7742B}"/>
                  </a:ext>
                </a:extLst>
              </p:cNvPr>
              <p:cNvGrpSpPr/>
              <p:nvPr/>
            </p:nvGrpSpPr>
            <p:grpSpPr>
              <a:xfrm>
                <a:off x="807018" y="0"/>
                <a:ext cx="5832802" cy="9144000"/>
                <a:chOff x="569682" y="0"/>
                <a:chExt cx="5832802" cy="9292503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9B38B565-585D-4A3D-9B47-B7FF31B302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69682" y="0"/>
                  <a:ext cx="5832802" cy="9144000"/>
                </a:xfrm>
                <a:prstGeom prst="rect">
                  <a:avLst/>
                </a:prstGeom>
              </p:spPr>
            </p:pic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58382E26-829C-48D7-8476-E8EE859AF2D9}"/>
                    </a:ext>
                  </a:extLst>
                </p:cNvPr>
                <p:cNvSpPr/>
                <p:nvPr/>
              </p:nvSpPr>
              <p:spPr>
                <a:xfrm>
                  <a:off x="2036097" y="138513"/>
                  <a:ext cx="871240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" name="Rectangle 7">
                  <a:extLst>
                    <a:ext uri="{FF2B5EF4-FFF2-40B4-BE49-F238E27FC236}">
                      <a16:creationId xmlns:a16="http://schemas.microsoft.com/office/drawing/2014/main" id="{BDE6D3AC-9C46-4289-8AAA-19FB14992915}"/>
                    </a:ext>
                  </a:extLst>
                </p:cNvPr>
                <p:cNvSpPr/>
                <p:nvPr/>
              </p:nvSpPr>
              <p:spPr>
                <a:xfrm>
                  <a:off x="4271493" y="138513"/>
                  <a:ext cx="2052142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9" name="Rectangle 8">
                  <a:extLst>
                    <a:ext uri="{FF2B5EF4-FFF2-40B4-BE49-F238E27FC236}">
                      <a16:creationId xmlns:a16="http://schemas.microsoft.com/office/drawing/2014/main" id="{1255CD93-8C20-475C-A123-459FBE02ECD3}"/>
                    </a:ext>
                  </a:extLst>
                </p:cNvPr>
                <p:cNvSpPr/>
                <p:nvPr/>
              </p:nvSpPr>
              <p:spPr>
                <a:xfrm>
                  <a:off x="5172719" y="1646202"/>
                  <a:ext cx="853833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C1C349BC-C2BF-4E23-8B07-CBC3638DCA90}"/>
                    </a:ext>
                  </a:extLst>
                </p:cNvPr>
                <p:cNvSpPr/>
                <p:nvPr/>
              </p:nvSpPr>
              <p:spPr>
                <a:xfrm>
                  <a:off x="4885025" y="3202630"/>
                  <a:ext cx="983339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1" name="Rectangle 10">
                  <a:extLst>
                    <a:ext uri="{FF2B5EF4-FFF2-40B4-BE49-F238E27FC236}">
                      <a16:creationId xmlns:a16="http://schemas.microsoft.com/office/drawing/2014/main" id="{A52069BC-5F03-4847-A86A-E5EB3ACF51D0}"/>
                    </a:ext>
                  </a:extLst>
                </p:cNvPr>
                <p:cNvSpPr/>
                <p:nvPr/>
              </p:nvSpPr>
              <p:spPr>
                <a:xfrm>
                  <a:off x="5955684" y="3202629"/>
                  <a:ext cx="394960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" name="Rectangle 11">
                  <a:extLst>
                    <a:ext uri="{FF2B5EF4-FFF2-40B4-BE49-F238E27FC236}">
                      <a16:creationId xmlns:a16="http://schemas.microsoft.com/office/drawing/2014/main" id="{72315928-3F24-4989-968F-612D8315EFCB}"/>
                    </a:ext>
                  </a:extLst>
                </p:cNvPr>
                <p:cNvSpPr/>
                <p:nvPr/>
              </p:nvSpPr>
              <p:spPr>
                <a:xfrm>
                  <a:off x="1057789" y="4748960"/>
                  <a:ext cx="365898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3" name="Rectangle 12">
                  <a:extLst>
                    <a:ext uri="{FF2B5EF4-FFF2-40B4-BE49-F238E27FC236}">
                      <a16:creationId xmlns:a16="http://schemas.microsoft.com/office/drawing/2014/main" id="{BA8A2D9F-24DD-4A0D-BD56-6EB15F1ED8B5}"/>
                    </a:ext>
                  </a:extLst>
                </p:cNvPr>
                <p:cNvSpPr/>
                <p:nvPr/>
              </p:nvSpPr>
              <p:spPr>
                <a:xfrm>
                  <a:off x="3066960" y="4740566"/>
                  <a:ext cx="2022042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A4CA967F-FB39-4F31-A90E-82FC8D4D72FF}"/>
                    </a:ext>
                  </a:extLst>
                </p:cNvPr>
                <p:cNvSpPr/>
                <p:nvPr/>
              </p:nvSpPr>
              <p:spPr>
                <a:xfrm>
                  <a:off x="5830739" y="4740566"/>
                  <a:ext cx="519905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8CDD25AA-EF0E-4BBB-8F49-28C6775E91CA}"/>
                    </a:ext>
                  </a:extLst>
                </p:cNvPr>
                <p:cNvSpPr/>
                <p:nvPr/>
              </p:nvSpPr>
              <p:spPr>
                <a:xfrm>
                  <a:off x="1053270" y="6289477"/>
                  <a:ext cx="428289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C1238392-FFBE-4EAD-B51F-EAAB6BECF2D2}"/>
                    </a:ext>
                  </a:extLst>
                </p:cNvPr>
                <p:cNvSpPr/>
                <p:nvPr/>
              </p:nvSpPr>
              <p:spPr>
                <a:xfrm>
                  <a:off x="2179862" y="6289477"/>
                  <a:ext cx="837272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250F7906-785A-4A35-AD65-1BAEF4735872}"/>
                    </a:ext>
                  </a:extLst>
                </p:cNvPr>
                <p:cNvSpPr/>
                <p:nvPr/>
              </p:nvSpPr>
              <p:spPr>
                <a:xfrm>
                  <a:off x="3508511" y="6289477"/>
                  <a:ext cx="519479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8" name="Rectangle 17">
                  <a:extLst>
                    <a:ext uri="{FF2B5EF4-FFF2-40B4-BE49-F238E27FC236}">
                      <a16:creationId xmlns:a16="http://schemas.microsoft.com/office/drawing/2014/main" id="{5E51D1F7-1968-462B-A84E-DDB57537779A}"/>
                    </a:ext>
                  </a:extLst>
                </p:cNvPr>
                <p:cNvSpPr/>
                <p:nvPr/>
              </p:nvSpPr>
              <p:spPr>
                <a:xfrm>
                  <a:off x="2410383" y="7794643"/>
                  <a:ext cx="155340" cy="1298573"/>
                </a:xfrm>
                <a:prstGeom prst="rect">
                  <a:avLst/>
                </a:prstGeom>
                <a:solidFill>
                  <a:srgbClr val="FFC000">
                    <a:alpha val="33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2B96FC85-761F-4C6B-B825-C13A4D127AB7}"/>
                    </a:ext>
                  </a:extLst>
                </p:cNvPr>
                <p:cNvSpPr txBox="1"/>
                <p:nvPr/>
              </p:nvSpPr>
              <p:spPr>
                <a:xfrm>
                  <a:off x="2205815" y="1380597"/>
                  <a:ext cx="4555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M1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2A95541D-99CD-4BA9-82B2-37063F2ED4A6}"/>
                    </a:ext>
                  </a:extLst>
                </p:cNvPr>
                <p:cNvSpPr txBox="1"/>
                <p:nvPr/>
              </p:nvSpPr>
              <p:spPr>
                <a:xfrm>
                  <a:off x="5061892" y="1380596"/>
                  <a:ext cx="4555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M2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324EE9C1-1AF5-4722-8346-DFE1A5BCE3F3}"/>
                    </a:ext>
                  </a:extLst>
                </p:cNvPr>
                <p:cNvSpPr txBox="1"/>
                <p:nvPr/>
              </p:nvSpPr>
              <p:spPr>
                <a:xfrm>
                  <a:off x="5426999" y="2866406"/>
                  <a:ext cx="4555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M3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513F4377-DB66-4207-BE73-5A9E5E0D6168}"/>
                    </a:ext>
                  </a:extLst>
                </p:cNvPr>
                <p:cNvSpPr txBox="1"/>
                <p:nvPr/>
              </p:nvSpPr>
              <p:spPr>
                <a:xfrm>
                  <a:off x="5098752" y="4434650"/>
                  <a:ext cx="4555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M4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40385B4B-AA1F-4DC6-997B-2E780832B52C}"/>
                    </a:ext>
                  </a:extLst>
                </p:cNvPr>
                <p:cNvSpPr txBox="1"/>
                <p:nvPr/>
              </p:nvSpPr>
              <p:spPr>
                <a:xfrm>
                  <a:off x="5900490" y="4435639"/>
                  <a:ext cx="4555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M5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186D0DD9-93A6-407A-A9AA-8DE2FBC1405B}"/>
                    </a:ext>
                  </a:extLst>
                </p:cNvPr>
                <p:cNvSpPr txBox="1"/>
                <p:nvPr/>
              </p:nvSpPr>
              <p:spPr>
                <a:xfrm>
                  <a:off x="3827315" y="5983226"/>
                  <a:ext cx="4555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M6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5FAED849-4CD1-498F-A27E-47793B424620}"/>
                    </a:ext>
                  </a:extLst>
                </p:cNvPr>
                <p:cNvSpPr txBox="1"/>
                <p:nvPr/>
              </p:nvSpPr>
              <p:spPr>
                <a:xfrm>
                  <a:off x="5868364" y="5983226"/>
                  <a:ext cx="4555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M7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403B3130-D6F3-4188-993E-2165ACDF2B2E}"/>
                    </a:ext>
                  </a:extLst>
                </p:cNvPr>
                <p:cNvSpPr txBox="1"/>
                <p:nvPr/>
              </p:nvSpPr>
              <p:spPr>
                <a:xfrm>
                  <a:off x="2137275" y="7505080"/>
                  <a:ext cx="6415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MBD</a:t>
                  </a:r>
                  <a:endPara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3D3FD06-E7D0-45E1-AD2C-E92434100CE2}"/>
                    </a:ext>
                  </a:extLst>
                </p:cNvPr>
                <p:cNvSpPr txBox="1"/>
                <p:nvPr/>
              </p:nvSpPr>
              <p:spPr>
                <a:xfrm>
                  <a:off x="3584698" y="7505079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522F8262-A3BB-4E82-9070-D7418A87B301}"/>
                    </a:ext>
                  </a:extLst>
                </p:cNvPr>
                <p:cNvSpPr txBox="1"/>
                <p:nvPr/>
              </p:nvSpPr>
              <p:spPr>
                <a:xfrm>
                  <a:off x="2366458" y="9046282"/>
                  <a:ext cx="28405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I</a:t>
                  </a:r>
                </a:p>
              </p:txBody>
            </p:sp>
          </p:grpSp>
          <p:pic>
            <p:nvPicPr>
              <p:cNvPr id="1026" name="Picture 2" descr="http://multalin.toulouse.inra.fr/multalin/result/1576684113.gif">
                <a:extLst>
                  <a:ext uri="{FF2B5EF4-FFF2-40B4-BE49-F238E27FC236}">
                    <a16:creationId xmlns:a16="http://schemas.microsoft.com/office/drawing/2014/main" id="{06981AAF-7BBB-4907-AC18-ECAE346E70F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12" t="760" r="86658" b="88876"/>
              <a:stretch/>
            </p:blipFill>
            <p:spPr bwMode="auto">
              <a:xfrm>
                <a:off x="765411" y="96459"/>
                <a:ext cx="462816" cy="139195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30" name="Picture 2" descr="http://multalin.toulouse.inra.fr/multalin/result/1576684113.gif">
              <a:extLst>
                <a:ext uri="{FF2B5EF4-FFF2-40B4-BE49-F238E27FC236}">
                  <a16:creationId xmlns:a16="http://schemas.microsoft.com/office/drawing/2014/main" id="{D0CAF09F-4AB1-4FAC-B9D2-E57464B3207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2" t="760" r="86658" b="88876"/>
            <a:stretch/>
          </p:blipFill>
          <p:spPr bwMode="auto">
            <a:xfrm>
              <a:off x="761896" y="1582084"/>
              <a:ext cx="466331" cy="1391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" name="Picture 2" descr="http://multalin.toulouse.inra.fr/multalin/result/1576684113.gif">
              <a:extLst>
                <a:ext uri="{FF2B5EF4-FFF2-40B4-BE49-F238E27FC236}">
                  <a16:creationId xmlns:a16="http://schemas.microsoft.com/office/drawing/2014/main" id="{D67817D2-E04F-416B-BF8D-7718F408D16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2" t="760" r="86658" b="88876"/>
            <a:stretch/>
          </p:blipFill>
          <p:spPr bwMode="auto">
            <a:xfrm>
              <a:off x="760688" y="3100335"/>
              <a:ext cx="467539" cy="14061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2" name="Picture 2" descr="http://multalin.toulouse.inra.fr/multalin/result/1576684113.gif">
              <a:extLst>
                <a:ext uri="{FF2B5EF4-FFF2-40B4-BE49-F238E27FC236}">
                  <a16:creationId xmlns:a16="http://schemas.microsoft.com/office/drawing/2014/main" id="{6EE80E54-926F-4628-9F9A-96FF055149D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2" t="760" r="86658" b="88876"/>
            <a:stretch/>
          </p:blipFill>
          <p:spPr bwMode="auto">
            <a:xfrm>
              <a:off x="760688" y="4617952"/>
              <a:ext cx="467539" cy="14061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3" name="Picture 2" descr="http://multalin.toulouse.inra.fr/multalin/result/1576684113.gif">
              <a:extLst>
                <a:ext uri="{FF2B5EF4-FFF2-40B4-BE49-F238E27FC236}">
                  <a16:creationId xmlns:a16="http://schemas.microsoft.com/office/drawing/2014/main" id="{ECBFD09E-6041-49A2-8B28-9A1F876C77F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2" t="760" r="86658" b="88876"/>
            <a:stretch/>
          </p:blipFill>
          <p:spPr bwMode="auto">
            <a:xfrm>
              <a:off x="760688" y="6150129"/>
              <a:ext cx="467539" cy="13805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4" name="Picture 2" descr="http://multalin.toulouse.inra.fr/multalin/result/1576684113.gif">
              <a:extLst>
                <a:ext uri="{FF2B5EF4-FFF2-40B4-BE49-F238E27FC236}">
                  <a16:creationId xmlns:a16="http://schemas.microsoft.com/office/drawing/2014/main" id="{C034E68E-FFDB-4BE3-BED2-8F88F2304D6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2" t="760" r="86658" b="88876"/>
            <a:stretch/>
          </p:blipFill>
          <p:spPr bwMode="auto">
            <a:xfrm>
              <a:off x="765411" y="7632944"/>
              <a:ext cx="462816" cy="1391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A596DDCF-FE6E-4D68-BC15-F54D2FAFB5AA}"/>
              </a:ext>
            </a:extLst>
          </p:cNvPr>
          <p:cNvSpPr txBox="1"/>
          <p:nvPr/>
        </p:nvSpPr>
        <p:spPr>
          <a:xfrm>
            <a:off x="-17182" y="-15376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9474199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31ADB44-6444-49C0-9EC0-FE10FF2F00AA}"/>
              </a:ext>
            </a:extLst>
          </p:cNvPr>
          <p:cNvSpPr txBox="1"/>
          <p:nvPr/>
        </p:nvSpPr>
        <p:spPr>
          <a:xfrm>
            <a:off x="-17182" y="-15376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AE7760D0-4597-47F4-A7FC-D2ACBEE37B1A}"/>
              </a:ext>
            </a:extLst>
          </p:cNvPr>
          <p:cNvGrpSpPr/>
          <p:nvPr/>
        </p:nvGrpSpPr>
        <p:grpSpPr>
          <a:xfrm>
            <a:off x="1550588" y="134624"/>
            <a:ext cx="3756825" cy="8857415"/>
            <a:chOff x="1498536" y="134624"/>
            <a:chExt cx="3756825" cy="8857415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F95EACD3-C794-4E21-8947-F44E86A7C88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498536" y="6406155"/>
              <a:ext cx="3756825" cy="2585884"/>
              <a:chOff x="780040" y="2120086"/>
              <a:chExt cx="2474116" cy="1932264"/>
            </a:xfrm>
          </p:grpSpPr>
          <p:pic>
            <p:nvPicPr>
              <p:cNvPr id="21" name="Picture 20" descr="Screen Clipping">
                <a:extLst>
                  <a:ext uri="{FF2B5EF4-FFF2-40B4-BE49-F238E27FC236}">
                    <a16:creationId xmlns:a16="http://schemas.microsoft.com/office/drawing/2014/main" id="{E0376BBA-D99E-4E0A-A3D6-9483E5E61D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80040" y="2120086"/>
                <a:ext cx="2474116" cy="1932264"/>
              </a:xfrm>
              <a:prstGeom prst="rect">
                <a:avLst/>
              </a:prstGeom>
            </p:spPr>
          </p:pic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BD752BF4-E3DD-4CAE-8F11-45D13FB4907B}"/>
                  </a:ext>
                </a:extLst>
              </p:cNvPr>
              <p:cNvSpPr/>
              <p:nvPr/>
            </p:nvSpPr>
            <p:spPr>
              <a:xfrm>
                <a:off x="1765993" y="2231120"/>
                <a:ext cx="502209" cy="805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73152" tIns="36576" rIns="73152" bIns="3657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40"/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2D496BBD-A0AB-44E0-A3EE-7FDE02288E1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49941" y="396490"/>
              <a:ext cx="3608240" cy="2585884"/>
              <a:chOff x="3701697" y="2120086"/>
              <a:chExt cx="2376263" cy="1932264"/>
            </a:xfrm>
          </p:grpSpPr>
          <p:pic>
            <p:nvPicPr>
              <p:cNvPr id="18" name="Picture 17" descr="Screen Clipping">
                <a:extLst>
                  <a:ext uri="{FF2B5EF4-FFF2-40B4-BE49-F238E27FC236}">
                    <a16:creationId xmlns:a16="http://schemas.microsoft.com/office/drawing/2014/main" id="{7A1A0C17-4031-4907-A1C7-24464F6864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01697" y="2120086"/>
                <a:ext cx="2376263" cy="1932264"/>
              </a:xfrm>
              <a:prstGeom prst="rect">
                <a:avLst/>
              </a:prstGeom>
            </p:spPr>
          </p:pic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32B3DC1E-91B4-4441-8E06-1B55C3CA1DDA}"/>
                  </a:ext>
                </a:extLst>
              </p:cNvPr>
              <p:cNvSpPr/>
              <p:nvPr/>
            </p:nvSpPr>
            <p:spPr>
              <a:xfrm>
                <a:off x="4686679" y="2231120"/>
                <a:ext cx="502209" cy="805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73152" tIns="36576" rIns="73152" bIns="3657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40"/>
              </a:p>
            </p:txBody>
          </p:sp>
        </p:grpSp>
        <p:pic>
          <p:nvPicPr>
            <p:cNvPr id="12" name="Picture 11" descr="Screen Clipping">
              <a:extLst>
                <a:ext uri="{FF2B5EF4-FFF2-40B4-BE49-F238E27FC236}">
                  <a16:creationId xmlns:a16="http://schemas.microsoft.com/office/drawing/2014/main" id="{2CB1B3AC-3349-4CD2-88D0-87528D44EE2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9940" y="3405280"/>
              <a:ext cx="3663344" cy="2517499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57FB298-4733-4EEB-BA11-2C7F98C7F377}"/>
                </a:ext>
              </a:extLst>
            </p:cNvPr>
            <p:cNvSpPr/>
            <p:nvPr/>
          </p:nvSpPr>
          <p:spPr>
            <a:xfrm>
              <a:off x="3613407" y="5188592"/>
              <a:ext cx="647090" cy="9146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3152" tIns="36576" rIns="73152" bIns="365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44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4B60D86-4E85-4F00-A28D-4DF96D1C0EBD}"/>
                </a:ext>
              </a:extLst>
            </p:cNvPr>
            <p:cNvSpPr txBox="1"/>
            <p:nvPr/>
          </p:nvSpPr>
          <p:spPr>
            <a:xfrm>
              <a:off x="1915297" y="6377124"/>
              <a:ext cx="3126258" cy="1908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40" b="1" i="1" dirty="0"/>
                <a:t>FaMLO12-7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863F0EC-5A53-4788-9C21-37989516001B}"/>
                </a:ext>
              </a:extLst>
            </p:cNvPr>
            <p:cNvSpPr txBox="1"/>
            <p:nvPr/>
          </p:nvSpPr>
          <p:spPr>
            <a:xfrm>
              <a:off x="1816443" y="134624"/>
              <a:ext cx="3225113" cy="261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dirty="0"/>
                <a:t>FaMLO5-2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6059152-EF36-446E-B9B5-A11C9898DA94}"/>
                </a:ext>
              </a:extLst>
            </p:cNvPr>
            <p:cNvSpPr txBox="1"/>
            <p:nvPr/>
          </p:nvSpPr>
          <p:spPr>
            <a:xfrm>
              <a:off x="1816442" y="3169412"/>
              <a:ext cx="32251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dirty="0"/>
                <a:t>FaMLO5-3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6A93EC8-1412-4E17-AA1C-5A51B8B51C3C}"/>
                </a:ext>
              </a:extLst>
            </p:cNvPr>
            <p:cNvSpPr txBox="1"/>
            <p:nvPr/>
          </p:nvSpPr>
          <p:spPr>
            <a:xfrm>
              <a:off x="1915297" y="6362488"/>
              <a:ext cx="300269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(</a:t>
              </a:r>
              <a:r>
                <a:rPr lang="en-US" sz="1100" i="1" dirty="0"/>
                <a:t>maker-Fvb4-augustus-gene-48.50</a:t>
              </a:r>
              <a:r>
                <a:rPr lang="en-US" sz="1100" dirty="0"/>
                <a:t>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A2857B1-0A52-4E64-B940-E960E162974F}"/>
                </a:ext>
              </a:extLst>
            </p:cNvPr>
            <p:cNvSpPr txBox="1"/>
            <p:nvPr/>
          </p:nvSpPr>
          <p:spPr>
            <a:xfrm>
              <a:off x="1816443" y="364655"/>
              <a:ext cx="3225114" cy="2539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/>
                <a:t>(</a:t>
              </a:r>
              <a:r>
                <a:rPr lang="en-US" sz="1050" i="1" dirty="0"/>
                <a:t>snap_masked-Fvb3-2-processed-gene-33.29</a:t>
              </a:r>
              <a:r>
                <a:rPr lang="en-US" sz="1050" dirty="0"/>
                <a:t>)</a:t>
              </a:r>
              <a:endParaRPr lang="en-US" sz="1050" i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F59A7CF-161C-4B1E-B83C-8ABEEA7976B8}"/>
                </a:ext>
              </a:extLst>
            </p:cNvPr>
            <p:cNvSpPr txBox="1"/>
            <p:nvPr/>
          </p:nvSpPr>
          <p:spPr>
            <a:xfrm>
              <a:off x="1816443" y="3411787"/>
              <a:ext cx="3225114" cy="2539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/>
                <a:t>(</a:t>
              </a:r>
              <a:r>
                <a:rPr lang="en-US" sz="1050" i="1" dirty="0"/>
                <a:t>snap_masked-Fvb3-3-processed-gene-28.38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0D0958D-2F33-41EE-8E77-B7F72FCD6092}"/>
                </a:ext>
              </a:extLst>
            </p:cNvPr>
            <p:cNvSpPr txBox="1"/>
            <p:nvPr/>
          </p:nvSpPr>
          <p:spPr>
            <a:xfrm>
              <a:off x="1804086" y="6140500"/>
              <a:ext cx="32251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dirty="0"/>
                <a:t>FaMLO12-7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DD79315-6142-4DEF-97C4-4ADA1C1B2789}"/>
                </a:ext>
              </a:extLst>
            </p:cNvPr>
            <p:cNvSpPr txBox="1"/>
            <p:nvPr/>
          </p:nvSpPr>
          <p:spPr>
            <a:xfrm>
              <a:off x="4270055" y="3719800"/>
              <a:ext cx="64793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P &lt; 2.2e-16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FFF8B8F-26B0-40A4-95D8-01BEA5FF9CF9}"/>
                </a:ext>
              </a:extLst>
            </p:cNvPr>
            <p:cNvSpPr txBox="1"/>
            <p:nvPr/>
          </p:nvSpPr>
          <p:spPr>
            <a:xfrm>
              <a:off x="4286362" y="723365"/>
              <a:ext cx="49084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P =0.59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D5B7899-ECA1-48F2-A7AB-6F1E840981EB}"/>
                </a:ext>
              </a:extLst>
            </p:cNvPr>
            <p:cNvSpPr txBox="1"/>
            <p:nvPr/>
          </p:nvSpPr>
          <p:spPr>
            <a:xfrm>
              <a:off x="4346999" y="6738364"/>
              <a:ext cx="57099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P &lt; 4e-09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A9BCDC3E-7BE7-4629-B1A3-AE05343734FC}"/>
                </a:ext>
              </a:extLst>
            </p:cNvPr>
            <p:cNvSpPr/>
            <p:nvPr/>
          </p:nvSpPr>
          <p:spPr>
            <a:xfrm>
              <a:off x="2239347" y="723365"/>
              <a:ext cx="756311" cy="1318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2234A665-97C0-4704-B137-82AD251EC88B}"/>
                </a:ext>
              </a:extLst>
            </p:cNvPr>
            <p:cNvSpPr/>
            <p:nvPr/>
          </p:nvSpPr>
          <p:spPr>
            <a:xfrm>
              <a:off x="2531842" y="3745082"/>
              <a:ext cx="756311" cy="1318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4CB5C83B-D6F1-4D61-BCC2-8DEE3BDF68F5}"/>
                </a:ext>
              </a:extLst>
            </p:cNvPr>
            <p:cNvSpPr/>
            <p:nvPr/>
          </p:nvSpPr>
          <p:spPr>
            <a:xfrm>
              <a:off x="3289264" y="6747967"/>
              <a:ext cx="756311" cy="1318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51159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4</TotalTime>
  <Words>160</Words>
  <Application>Microsoft Office PowerPoint</Application>
  <PresentationFormat>Letter Paper (8.5x11 in)</PresentationFormat>
  <Paragraphs>29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ald tapia</dc:creator>
  <cp:lastModifiedBy>Tapia,Ronald R</cp:lastModifiedBy>
  <cp:revision>42</cp:revision>
  <dcterms:created xsi:type="dcterms:W3CDTF">2019-05-04T22:54:03Z</dcterms:created>
  <dcterms:modified xsi:type="dcterms:W3CDTF">2019-12-18T19:29:29Z</dcterms:modified>
</cp:coreProperties>
</file>